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wmf" ContentType="image/x-wmf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embeddings/oleObject3.xlsx" ContentType="application/vnd.openxmlformats-officedocument.spreadsheetml.sheet"/>
  <Override PartName="/ppt/embeddings/oleObject4.xlsx" ContentType="application/vnd.openxmlformats-officedocument.spreadsheetml.sheet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10D00EC-B1CE-48D0-9017-32A1EECEC3CE}" type="slidenum">
              <a:rPr b="0" lang="en-IN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10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8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0B3F5D8-FF9E-435E-AE10-AB415D1F98A8}" type="slidenum">
              <a:rPr b="0" lang="en-IN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11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AU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1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DD34A1F-4C79-41AA-B0E6-5895997ABA2E}" type="slidenum">
              <a:rPr b="0" lang="en-IN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D3F9E1-7ACA-4505-9FBA-B984D57FF6B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A9C239-14D6-4027-9343-DB3FBB3C30E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32FBD7-F23A-45BD-9CEC-8925A4BCBD4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6774C0-95A3-4A08-A796-755C3E9BE6E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6A36D5-447D-48CC-B266-110EA63FE33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BDE07D-9E8B-45DB-9EBA-873CFF86685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785ADA-290B-43CA-97CA-E2C45E30AB0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8CCA1E-6FF2-4606-B694-B955EBC4C64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97FE04-731B-42E0-BEC8-3F2B9ABC89B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A5A741-61DE-4487-BFA9-41BFCE7F70D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700B03-61F0-4C5D-8448-680573853B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AF8170-1CAE-492F-A118-F6DCFF80DE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09F1834-9358-4CE4-A887-11720CF1BEA2}" type="datetime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08/29/26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E74779B-CEA0-475A-AC1E-F06C2BD2D80D}" type="slidenum">
              <a:rPr b="0" lang="en-IN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3.png"/><Relationship Id="rId3" Type="http://schemas.openxmlformats.org/officeDocument/2006/relationships/package" Target="../embeddings/oleObject2.xlsx"/><Relationship Id="rId4" Type="http://schemas.openxmlformats.org/officeDocument/2006/relationships/image" Target="../media/image4.png"/><Relationship Id="rId5" Type="http://schemas.openxmlformats.org/officeDocument/2006/relationships/package" Target="../embeddings/oleObject3.xlsx"/><Relationship Id="rId6" Type="http://schemas.openxmlformats.org/officeDocument/2006/relationships/image" Target="../media/image3.png"/><Relationship Id="rId7" Type="http://schemas.openxmlformats.org/officeDocument/2006/relationships/package" Target="../embeddings/oleObject4.xlsx"/><Relationship Id="rId8" Type="http://schemas.openxmlformats.org/officeDocument/2006/relationships/image" Target="../media/image5.wmf"/><Relationship Id="rId9" Type="http://schemas.openxmlformats.org/officeDocument/2006/relationships/slideLayout" Target="../slideLayouts/slideLayout1.xml"/><Relationship Id="rId10" Type="http://schemas.openxmlformats.org/officeDocument/2006/relationships/notesSlide" Target="../notesSlides/notesSlide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6"/>
          <p:cNvSpPr/>
          <p:nvPr/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C089C20-0602-4CAE-81E0-6BE9135BE15C}" type="slidenum">
              <a:rPr b="0" lang="en-IN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9" name="Group 8"/>
          <p:cNvGrpSpPr/>
          <p:nvPr/>
        </p:nvGrpSpPr>
        <p:grpSpPr>
          <a:xfrm>
            <a:off x="907560" y="1547640"/>
            <a:ext cx="5085000" cy="2303280"/>
            <a:chOff x="907560" y="1547640"/>
            <a:chExt cx="5085000" cy="2303280"/>
          </a:xfrm>
        </p:grpSpPr>
        <p:pic>
          <p:nvPicPr>
            <p:cNvPr id="50" name="Picture 4" descr=""/>
            <p:cNvPicPr/>
            <p:nvPr/>
          </p:nvPicPr>
          <p:blipFill>
            <a:blip r:embed="rId1"/>
            <a:stretch/>
          </p:blipFill>
          <p:spPr>
            <a:xfrm>
              <a:off x="949320" y="1553760"/>
              <a:ext cx="2449440" cy="2297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Picture 5" descr=""/>
            <p:cNvPicPr/>
            <p:nvPr/>
          </p:nvPicPr>
          <p:blipFill>
            <a:blip r:embed="rId2"/>
            <a:stretch/>
          </p:blipFill>
          <p:spPr>
            <a:xfrm>
              <a:off x="3543120" y="1547640"/>
              <a:ext cx="2449440" cy="2297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2" name="Rectangle 6"/>
            <p:cNvSpPr/>
            <p:nvPr/>
          </p:nvSpPr>
          <p:spPr>
            <a:xfrm>
              <a:off x="907560" y="3498480"/>
              <a:ext cx="1488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ffff00"/>
                  </a:solidFill>
                  <a:latin typeface="Times New Roman"/>
                </a:rPr>
                <a:t>EGFP PC12 cells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Rectangle 7"/>
            <p:cNvSpPr/>
            <p:nvPr/>
          </p:nvSpPr>
          <p:spPr>
            <a:xfrm>
              <a:off x="3562920" y="3524040"/>
              <a:ext cx="1569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ffff00"/>
                  </a:solidFill>
                  <a:latin typeface="Times New Roman"/>
                </a:rPr>
                <a:t>SOCS6 PC12 cells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54" name="Text Box 27"/>
          <p:cNvSpPr/>
          <p:nvPr/>
        </p:nvSpPr>
        <p:spPr>
          <a:xfrm>
            <a:off x="478080" y="133200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Text Box 35"/>
          <p:cNvSpPr/>
          <p:nvPr/>
        </p:nvSpPr>
        <p:spPr>
          <a:xfrm>
            <a:off x="0" y="5292720"/>
            <a:ext cx="6626160" cy="1919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266760" indent="-266760"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200" spc="-1" strike="noStrike">
                <a:solidFill>
                  <a:srgbClr val="000000"/>
                </a:solidFill>
                <a:latin typeface="Times New Roman"/>
              </a:rPr>
              <a:t>        </a:t>
            </a:r>
            <a:r>
              <a:rPr b="1" lang="en-AU" sz="1200" spc="-1" strike="noStrike">
                <a:solidFill>
                  <a:srgbClr val="000000"/>
                </a:solidFill>
                <a:latin typeface="Times New Roman"/>
              </a:rPr>
              <a:t>Effect of SOCS6 on neuritic outgrowth of PC12 cells: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(A)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PC12 cells stable transfected with EGFP or SOCS6 EGFP were allowed to differentiate in the presence of NGF and observed under fluorescent microscope. </a:t>
            </a:r>
            <a:r>
              <a:rPr b="1" lang="en-IN" sz="1200" spc="-1" strike="noStrike">
                <a:solidFill>
                  <a:srgbClr val="000000"/>
                </a:solidFill>
                <a:latin typeface="Times New Roman"/>
              </a:rPr>
              <a:t>(B, C)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IN" sz="1200" spc="-1" strike="noStrike">
                <a:solidFill>
                  <a:srgbClr val="000000"/>
                </a:solidFill>
                <a:latin typeface="Times New Roman"/>
              </a:rPr>
              <a:t>PC12 cells stably transfected with EGFP or with SOCS6-EGFP were differentiated with NGF in the presence and absence of IGF-1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A</a:t>
            </a:r>
            <a:r>
              <a:rPr b="0" lang="en-IN" sz="1200" spc="-1" strike="noStrike">
                <a:solidFill>
                  <a:srgbClr val="000000"/>
                </a:solidFill>
                <a:latin typeface="Times New Roman"/>
              </a:rPr>
              <a:t>verage length of primary, secondary and tertiary branches in EGFP and SOCS6 stably transfected PC12 cells and average number of neurites per cell. N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eurite length was measured in randomly chosen cells. Statistical significance of the difference was determined using ANOVA.</a:t>
            </a:r>
            <a:r>
              <a:rPr b="0" lang="en-IN" sz="1200" spc="-1" strike="noStrike">
                <a:solidFill>
                  <a:srgbClr val="000000"/>
                </a:solidFill>
                <a:latin typeface="Times New Roman"/>
              </a:rPr>
              <a:t> The result shows the mean ± SE of n=3 combined experiments (**p&lt;0.01, *p&lt;0.05)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Neurite lengths were measured by tracing individual neurites (as described in experimental procedures) and results are expressed as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(B)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average of total primary, secondary and tertiary neurite lengths or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(C)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average number of neurites per cell. Scale bar 5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µ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M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TextBox 9"/>
          <p:cNvSpPr/>
          <p:nvPr/>
        </p:nvSpPr>
        <p:spPr>
          <a:xfrm>
            <a:off x="2435040" y="7885080"/>
            <a:ext cx="2152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600" spc="-1" strike="noStrike">
                <a:solidFill>
                  <a:srgbClr val="000000"/>
                </a:solidFill>
                <a:latin typeface="Times New Roman"/>
              </a:rPr>
              <a:t>Supplementary File S3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Rectangle 6"/>
          <p:cNvSpPr/>
          <p:nvPr/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EFBC6F4-DDE5-49A1-AD1B-E91E88BD7535}" type="slidenum">
              <a:rPr b="0" lang="en-IN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Slide Number Placeholder 3"/>
          <p:cNvSpPr/>
          <p:nvPr/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A916965-1BBF-4D04-924E-05AEC1BE469E}" type="slidenum">
              <a:rPr b="0" lang="en-IN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Text Box 6"/>
          <p:cNvSpPr/>
          <p:nvPr/>
        </p:nvSpPr>
        <p:spPr>
          <a:xfrm>
            <a:off x="1722960" y="746280"/>
            <a:ext cx="360720" cy="11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75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60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45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Text Box 7"/>
          <p:cNvSpPr/>
          <p:nvPr/>
        </p:nvSpPr>
        <p:spPr>
          <a:xfrm>
            <a:off x="1722960" y="2057400"/>
            <a:ext cx="360720" cy="11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30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15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 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Text Box 8"/>
          <p:cNvSpPr/>
          <p:nvPr/>
        </p:nvSpPr>
        <p:spPr>
          <a:xfrm rot="16200000">
            <a:off x="407520" y="1823760"/>
            <a:ext cx="2437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Average Neurite Length (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µ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m)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Text Box 9"/>
          <p:cNvSpPr/>
          <p:nvPr/>
        </p:nvSpPr>
        <p:spPr>
          <a:xfrm>
            <a:off x="1991160" y="3070080"/>
            <a:ext cx="27439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Primary     Secondary     Tertiary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Neurite       Neurite           Neurite 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Text Box 10"/>
          <p:cNvSpPr/>
          <p:nvPr/>
        </p:nvSpPr>
        <p:spPr>
          <a:xfrm>
            <a:off x="2419920" y="3546360"/>
            <a:ext cx="1758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Degree of Branching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Text Box 15"/>
          <p:cNvSpPr/>
          <p:nvPr/>
        </p:nvSpPr>
        <p:spPr>
          <a:xfrm>
            <a:off x="1792440" y="4208400"/>
            <a:ext cx="26316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Times New Roman"/>
              </a:rPr>
              <a:t>8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Text Box 16"/>
          <p:cNvSpPr/>
          <p:nvPr/>
        </p:nvSpPr>
        <p:spPr>
          <a:xfrm>
            <a:off x="1787760" y="4440240"/>
            <a:ext cx="26316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Times New Roman"/>
              </a:rPr>
              <a:t>7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Text Box 17"/>
          <p:cNvSpPr/>
          <p:nvPr/>
        </p:nvSpPr>
        <p:spPr>
          <a:xfrm>
            <a:off x="1787760" y="4681440"/>
            <a:ext cx="26316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Times New Roman"/>
              </a:rPr>
              <a:t>6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Text Box 18"/>
          <p:cNvSpPr/>
          <p:nvPr/>
        </p:nvSpPr>
        <p:spPr>
          <a:xfrm>
            <a:off x="1785960" y="4952880"/>
            <a:ext cx="26316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Times New Roman"/>
              </a:rPr>
              <a:t>5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Text Box 19"/>
          <p:cNvSpPr/>
          <p:nvPr/>
        </p:nvSpPr>
        <p:spPr>
          <a:xfrm>
            <a:off x="1787760" y="5726160"/>
            <a:ext cx="26316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Times New Roman"/>
              </a:rPr>
              <a:t>2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Text Box 20"/>
          <p:cNvSpPr/>
          <p:nvPr/>
        </p:nvSpPr>
        <p:spPr>
          <a:xfrm>
            <a:off x="1795680" y="5451480"/>
            <a:ext cx="26316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Times New Roman"/>
              </a:rPr>
              <a:t>3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Text Box 21"/>
          <p:cNvSpPr/>
          <p:nvPr/>
        </p:nvSpPr>
        <p:spPr>
          <a:xfrm>
            <a:off x="1785960" y="5969160"/>
            <a:ext cx="26316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Times New Roman"/>
              </a:rPr>
              <a:t>1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Text Box 22"/>
          <p:cNvSpPr/>
          <p:nvPr/>
        </p:nvSpPr>
        <p:spPr>
          <a:xfrm>
            <a:off x="1785960" y="5211720"/>
            <a:ext cx="26316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Times New Roman"/>
              </a:rPr>
              <a:t>4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Text Box 23"/>
          <p:cNvSpPr/>
          <p:nvPr/>
        </p:nvSpPr>
        <p:spPr>
          <a:xfrm>
            <a:off x="1787760" y="6226200"/>
            <a:ext cx="26316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Text Box 24"/>
          <p:cNvSpPr/>
          <p:nvPr/>
        </p:nvSpPr>
        <p:spPr>
          <a:xfrm rot="16200000">
            <a:off x="701280" y="4951440"/>
            <a:ext cx="17305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Average Number of 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Neurites Per Cell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Text Box 25"/>
          <p:cNvSpPr/>
          <p:nvPr/>
        </p:nvSpPr>
        <p:spPr>
          <a:xfrm>
            <a:off x="1941480" y="6359400"/>
            <a:ext cx="27943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Control    IGF-1    SOCS6  SOCS6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                                            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+ IGF-1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Text Box 27"/>
          <p:cNvSpPr/>
          <p:nvPr/>
        </p:nvSpPr>
        <p:spPr>
          <a:xfrm>
            <a:off x="314640" y="118584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Text Box 28"/>
          <p:cNvSpPr/>
          <p:nvPr/>
        </p:nvSpPr>
        <p:spPr>
          <a:xfrm>
            <a:off x="319320" y="434484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graphicFrame>
        <p:nvGraphicFramePr>
          <p:cNvPr id="77" name="Object 34"/>
          <p:cNvGraphicFramePr/>
          <p:nvPr/>
        </p:nvGraphicFramePr>
        <p:xfrm>
          <a:off x="4724280" y="4211640"/>
          <a:ext cx="1009800" cy="88272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78" name="Object 34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4724280" y="4211640"/>
                    <a:ext cx="1009800" cy="882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79" name="Object 28"/>
          <p:cNvGraphicFramePr/>
          <p:nvPr/>
        </p:nvGraphicFramePr>
        <p:xfrm>
          <a:off x="1916280" y="684360"/>
          <a:ext cx="2808000" cy="251928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80" name="Object 28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916280" y="684360"/>
                    <a:ext cx="2808000" cy="2519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81" name="Object 29"/>
          <p:cNvGraphicFramePr/>
          <p:nvPr/>
        </p:nvGraphicFramePr>
        <p:xfrm>
          <a:off x="4797360" y="755640"/>
          <a:ext cx="1009800" cy="882720"/>
        </p:xfrm>
        <a:graphic>
          <a:graphicData uri="http://schemas.openxmlformats.org/presentationml/2006/ole">
            <p:oleObj progId="Excel.Sheet.12" r:id="rId5" spid="">
              <p:embed/>
              <p:pic>
                <p:nvPicPr>
                  <p:cNvPr id="82" name="Object 29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4797360" y="755640"/>
                    <a:ext cx="1009800" cy="882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83" name="Object 30"/>
          <p:cNvGraphicFramePr/>
          <p:nvPr/>
        </p:nvGraphicFramePr>
        <p:xfrm>
          <a:off x="1916280" y="4148280"/>
          <a:ext cx="2952720" cy="2419200"/>
        </p:xfrm>
        <a:graphic>
          <a:graphicData uri="http://schemas.openxmlformats.org/presentationml/2006/ole">
            <p:oleObj progId="Excel.Sheet.12" r:id="rId7" spid="">
              <p:embed/>
              <p:pic>
                <p:nvPicPr>
                  <p:cNvPr id="84" name="Object 30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1916280" y="4148280"/>
                    <a:ext cx="2952720" cy="2419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5" name="AutoShape 32"/>
          <p:cNvSpPr/>
          <p:nvPr/>
        </p:nvSpPr>
        <p:spPr>
          <a:xfrm flipH="1" rot="16200000">
            <a:off x="2420640" y="396000"/>
            <a:ext cx="71280" cy="647640"/>
          </a:xfrm>
          <a:custGeom>
            <a:avLst/>
            <a:gdLst>
              <a:gd name="textAreaLeft" fmla="*/ 21240 w 71280"/>
              <a:gd name="textAreaRight" fmla="*/ 72000 w 71280"/>
              <a:gd name="textAreaTop" fmla="*/ 0 h 647640"/>
              <a:gd name="textAreaBottom" fmla="*/ 648000 h 6476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0"/>
                  <a:pt x="0" y="0"/>
                </a:cubicBezTo>
                <a:lnTo>
                  <a:pt x="0" y="21600"/>
                </a:lnTo>
                <a:cubicBezTo>
                  <a:pt x="0" y="21600"/>
                  <a:pt x="108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Text Box 33"/>
          <p:cNvSpPr/>
          <p:nvPr/>
        </p:nvSpPr>
        <p:spPr>
          <a:xfrm>
            <a:off x="2277000" y="476280"/>
            <a:ext cx="36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**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AutoShape 35"/>
          <p:cNvSpPr/>
          <p:nvPr/>
        </p:nvSpPr>
        <p:spPr>
          <a:xfrm flipH="1" rot="16200000">
            <a:off x="3355560" y="1975680"/>
            <a:ext cx="71640" cy="647640"/>
          </a:xfrm>
          <a:custGeom>
            <a:avLst/>
            <a:gdLst>
              <a:gd name="textAreaLeft" fmla="*/ 20520 w 71640"/>
              <a:gd name="textAreaRight" fmla="*/ 71640 w 71640"/>
              <a:gd name="textAreaTop" fmla="*/ 0 h 647640"/>
              <a:gd name="textAreaBottom" fmla="*/ 648000 h 6476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0"/>
                  <a:pt x="0" y="0"/>
                </a:cubicBezTo>
                <a:lnTo>
                  <a:pt x="0" y="21600"/>
                </a:lnTo>
                <a:cubicBezTo>
                  <a:pt x="0" y="21600"/>
                  <a:pt x="108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AutoShape 36"/>
          <p:cNvSpPr/>
          <p:nvPr/>
        </p:nvSpPr>
        <p:spPr>
          <a:xfrm flipH="1" rot="16200000">
            <a:off x="2350080" y="683280"/>
            <a:ext cx="71640" cy="504720"/>
          </a:xfrm>
          <a:custGeom>
            <a:avLst/>
            <a:gdLst>
              <a:gd name="textAreaLeft" fmla="*/ 20520 w 71640"/>
              <a:gd name="textAreaRight" fmla="*/ 71640 w 71640"/>
              <a:gd name="textAreaTop" fmla="*/ 0 h 504720"/>
              <a:gd name="textAreaBottom" fmla="*/ 505080 h 5047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0"/>
                  <a:pt x="0" y="0"/>
                </a:cubicBezTo>
                <a:lnTo>
                  <a:pt x="0" y="21600"/>
                </a:lnTo>
                <a:cubicBezTo>
                  <a:pt x="0" y="21600"/>
                  <a:pt x="108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AutoShape 38"/>
          <p:cNvSpPr/>
          <p:nvPr/>
        </p:nvSpPr>
        <p:spPr>
          <a:xfrm flipH="1" rot="16200000">
            <a:off x="2253240" y="948240"/>
            <a:ext cx="73080" cy="287280"/>
          </a:xfrm>
          <a:custGeom>
            <a:avLst/>
            <a:gdLst>
              <a:gd name="textAreaLeft" fmla="*/ 21240 w 73080"/>
              <a:gd name="textAreaRight" fmla="*/ 73440 w 73080"/>
              <a:gd name="textAreaTop" fmla="*/ 0 h 287280"/>
              <a:gd name="textAreaBottom" fmla="*/ 287640 h 28728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0"/>
                  <a:pt x="0" y="0"/>
                </a:cubicBezTo>
                <a:lnTo>
                  <a:pt x="0" y="21600"/>
                </a:lnTo>
                <a:cubicBezTo>
                  <a:pt x="0" y="21600"/>
                  <a:pt x="108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Text Box 39"/>
          <p:cNvSpPr/>
          <p:nvPr/>
        </p:nvSpPr>
        <p:spPr>
          <a:xfrm>
            <a:off x="2121480" y="861840"/>
            <a:ext cx="36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**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AutoShape 40"/>
          <p:cNvSpPr/>
          <p:nvPr/>
        </p:nvSpPr>
        <p:spPr>
          <a:xfrm flipH="1" rot="16200000">
            <a:off x="3247560" y="2299320"/>
            <a:ext cx="71280" cy="431640"/>
          </a:xfrm>
          <a:custGeom>
            <a:avLst/>
            <a:gdLst>
              <a:gd name="textAreaLeft" fmla="*/ 21240 w 71280"/>
              <a:gd name="textAreaRight" fmla="*/ 72000 w 71280"/>
              <a:gd name="textAreaTop" fmla="*/ 0 h 431640"/>
              <a:gd name="textAreaBottom" fmla="*/ 432000 h 4316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0"/>
                  <a:pt x="0" y="0"/>
                </a:cubicBezTo>
                <a:lnTo>
                  <a:pt x="0" y="21600"/>
                </a:lnTo>
                <a:cubicBezTo>
                  <a:pt x="0" y="21600"/>
                  <a:pt x="108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2" name="AutoShape 41"/>
          <p:cNvSpPr/>
          <p:nvPr/>
        </p:nvSpPr>
        <p:spPr>
          <a:xfrm flipH="1" rot="16200000">
            <a:off x="4113720" y="2446920"/>
            <a:ext cx="71640" cy="432000"/>
          </a:xfrm>
          <a:custGeom>
            <a:avLst/>
            <a:gdLst>
              <a:gd name="textAreaLeft" fmla="*/ 20520 w 71640"/>
              <a:gd name="textAreaRight" fmla="*/ 71640 w 71640"/>
              <a:gd name="textAreaTop" fmla="*/ 0 h 432000"/>
              <a:gd name="textAreaBottom" fmla="*/ 432360 h 4320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0"/>
                  <a:pt x="0" y="0"/>
                </a:cubicBezTo>
                <a:lnTo>
                  <a:pt x="0" y="21600"/>
                </a:lnTo>
                <a:cubicBezTo>
                  <a:pt x="0" y="21600"/>
                  <a:pt x="108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AutoShape 42"/>
          <p:cNvSpPr/>
          <p:nvPr/>
        </p:nvSpPr>
        <p:spPr>
          <a:xfrm flipH="1" rot="16200000">
            <a:off x="4208040" y="2123280"/>
            <a:ext cx="71640" cy="647640"/>
          </a:xfrm>
          <a:custGeom>
            <a:avLst/>
            <a:gdLst>
              <a:gd name="textAreaLeft" fmla="*/ 20520 w 71640"/>
              <a:gd name="textAreaRight" fmla="*/ 71640 w 71640"/>
              <a:gd name="textAreaTop" fmla="*/ 0 h 647640"/>
              <a:gd name="textAreaBottom" fmla="*/ 648000 h 6476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0"/>
                  <a:pt x="0" y="0"/>
                </a:cubicBezTo>
                <a:lnTo>
                  <a:pt x="0" y="21600"/>
                </a:lnTo>
                <a:cubicBezTo>
                  <a:pt x="0" y="21600"/>
                  <a:pt x="108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4" name="AutoShape 43"/>
          <p:cNvSpPr/>
          <p:nvPr/>
        </p:nvSpPr>
        <p:spPr>
          <a:xfrm flipH="1" rot="16200000">
            <a:off x="3176280" y="2591280"/>
            <a:ext cx="71280" cy="289080"/>
          </a:xfrm>
          <a:custGeom>
            <a:avLst/>
            <a:gdLst>
              <a:gd name="textAreaLeft" fmla="*/ 21240 w 71280"/>
              <a:gd name="textAreaRight" fmla="*/ 72000 w 71280"/>
              <a:gd name="textAreaTop" fmla="*/ 0 h 289080"/>
              <a:gd name="textAreaBottom" fmla="*/ 289080 h 28908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0"/>
                  <a:pt x="0" y="0"/>
                </a:cubicBezTo>
                <a:lnTo>
                  <a:pt x="0" y="21600"/>
                </a:lnTo>
                <a:cubicBezTo>
                  <a:pt x="0" y="21600"/>
                  <a:pt x="108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5" name="AutoShape 44"/>
          <p:cNvSpPr/>
          <p:nvPr/>
        </p:nvSpPr>
        <p:spPr>
          <a:xfrm flipH="1" rot="16200000">
            <a:off x="4041000" y="2710800"/>
            <a:ext cx="71280" cy="288720"/>
          </a:xfrm>
          <a:custGeom>
            <a:avLst/>
            <a:gdLst>
              <a:gd name="textAreaLeft" fmla="*/ 21240 w 71280"/>
              <a:gd name="textAreaRight" fmla="*/ 72000 w 71280"/>
              <a:gd name="textAreaTop" fmla="*/ 0 h 288720"/>
              <a:gd name="textAreaBottom" fmla="*/ 289080 h 2887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0800" y="0"/>
                  <a:pt x="0" y="0"/>
                  <a:pt x="0" y="0"/>
                </a:cubicBezTo>
                <a:lnTo>
                  <a:pt x="0" y="21600"/>
                </a:lnTo>
                <a:cubicBezTo>
                  <a:pt x="0" y="21600"/>
                  <a:pt x="108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Text Box 45"/>
          <p:cNvSpPr/>
          <p:nvPr/>
        </p:nvSpPr>
        <p:spPr>
          <a:xfrm>
            <a:off x="3993120" y="2433600"/>
            <a:ext cx="36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**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Text Box 46"/>
          <p:cNvSpPr/>
          <p:nvPr/>
        </p:nvSpPr>
        <p:spPr>
          <a:xfrm>
            <a:off x="4165200" y="219564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Text Box 47"/>
          <p:cNvSpPr/>
          <p:nvPr/>
        </p:nvSpPr>
        <p:spPr>
          <a:xfrm>
            <a:off x="3082320" y="249696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Text Box 48"/>
          <p:cNvSpPr/>
          <p:nvPr/>
        </p:nvSpPr>
        <p:spPr>
          <a:xfrm>
            <a:off x="2218320" y="704880"/>
            <a:ext cx="36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**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Text Box 49"/>
          <p:cNvSpPr/>
          <p:nvPr/>
        </p:nvSpPr>
        <p:spPr>
          <a:xfrm>
            <a:off x="3129480" y="2281320"/>
            <a:ext cx="36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**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Text Box 50"/>
          <p:cNvSpPr/>
          <p:nvPr/>
        </p:nvSpPr>
        <p:spPr>
          <a:xfrm>
            <a:off x="3142080" y="2050920"/>
            <a:ext cx="36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**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Text Box 51"/>
          <p:cNvSpPr/>
          <p:nvPr/>
        </p:nvSpPr>
        <p:spPr>
          <a:xfrm>
            <a:off x="3934800" y="261144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Text Box 52"/>
          <p:cNvSpPr/>
          <p:nvPr/>
        </p:nvSpPr>
        <p:spPr>
          <a:xfrm>
            <a:off x="4222080" y="421164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Text Box 53"/>
          <p:cNvSpPr/>
          <p:nvPr/>
        </p:nvSpPr>
        <p:spPr>
          <a:xfrm>
            <a:off x="3535920" y="4199040"/>
            <a:ext cx="36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**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Text Box 54"/>
          <p:cNvSpPr/>
          <p:nvPr/>
        </p:nvSpPr>
        <p:spPr>
          <a:xfrm>
            <a:off x="2873880" y="4478400"/>
            <a:ext cx="36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**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2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7-13T06:06:15Z</dcterms:created>
  <dc:creator>EGE I Lab</dc:creator>
  <dc:description/>
  <dc:language>en-US</dc:language>
  <cp:lastModifiedBy>Riya</cp:lastModifiedBy>
  <dcterms:modified xsi:type="dcterms:W3CDTF">2011-11-01T12:33:08Z</dcterms:modified>
  <cp:revision>104</cp:revision>
  <dc:subject/>
  <dc:title>PowerPoint Presentation</dc:title>
</cp:coreProperties>
</file>